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4"/>
  </p:notesMasterIdLst>
  <p:sldIdLst>
    <p:sldId id="259" r:id="rId2"/>
    <p:sldId id="260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5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7"/>
    <p:restoredTop sz="94629"/>
  </p:normalViewPr>
  <p:slideViewPr>
    <p:cSldViewPr snapToGrid="0" showGuides="1">
      <p:cViewPr>
        <p:scale>
          <a:sx n="120" d="100"/>
          <a:sy n="120" d="100"/>
        </p:scale>
        <p:origin x="204" y="-4611"/>
      </p:cViewPr>
      <p:guideLst>
        <p:guide orient="horz" pos="525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80th%20paper%20(&#65431;&#65400;&#65432;&#65405;&#32905;&#35930;&#29983;&#29987;)\22047MF&#9315;Table2&#12398;&#12467;&#12498;&#12442;&#1254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80th%20paper%20(&#65431;&#65400;&#65432;&#65405;&#32905;&#35930;&#29983;&#29987;)\22047MF&#9313;Table_SCFA2&#12398;&#12467;&#12498;&#12442;&#1254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80th%20paper%20(&#65431;&#65400;&#65432;&#65405;&#32905;&#35930;&#29983;&#29987;)\22047MF&#9313;Table_SCFA2&#12398;&#12467;&#12498;&#12442;&#1254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80th%20paper%20(&#65431;&#65400;&#65432;&#65405;&#32905;&#35930;&#29983;&#29987;)\22047MF&#9315;Table2&#12398;&#12467;&#12498;&#12442;&#12540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80th%20paper%20(&#65431;&#65400;&#65432;&#65405;&#32905;&#35930;&#29983;&#29987;)\22047MF&#9315;Table2&#12398;&#12467;&#12498;&#12442;&#12540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表1，SCFA'!$N$10</c:f>
              <c:strCache>
                <c:ptCount val="1"/>
                <c:pt idx="0">
                  <c:v>Acetate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SCFA'!$N$17:$N$19</c:f>
                <c:numCache>
                  <c:formatCode>General</c:formatCode>
                  <c:ptCount val="3"/>
                  <c:pt idx="0">
                    <c:v>2.751560119041673</c:v>
                  </c:pt>
                  <c:pt idx="1">
                    <c:v>4.5423761788241146</c:v>
                  </c:pt>
                  <c:pt idx="2">
                    <c:v>1.05230774904144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N$11:$N$13</c:f>
              <c:numCache>
                <c:formatCode>0_);[Red]\(0\)</c:formatCode>
                <c:ptCount val="3"/>
                <c:pt idx="0">
                  <c:v>63.662954861128306</c:v>
                </c:pt>
                <c:pt idx="1">
                  <c:v>58.362551980745693</c:v>
                </c:pt>
                <c:pt idx="2">
                  <c:v>60.7425106619243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A1-BB45-A0FF-1FD20A139DEA}"/>
            </c:ext>
          </c:extLst>
        </c:ser>
        <c:ser>
          <c:idx val="1"/>
          <c:order val="1"/>
          <c:tx>
            <c:strRef>
              <c:f>'表1，SCFA'!$O$10</c:f>
              <c:strCache>
                <c:ptCount val="1"/>
                <c:pt idx="0">
                  <c:v>Propionate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SCFA'!$O$17:$O$19</c:f>
                <c:numCache>
                  <c:formatCode>General</c:formatCode>
                  <c:ptCount val="3"/>
                  <c:pt idx="0">
                    <c:v>3.0818376839746571</c:v>
                  </c:pt>
                  <c:pt idx="1">
                    <c:v>2.7988805383968169</c:v>
                  </c:pt>
                  <c:pt idx="2">
                    <c:v>1.25477709817468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O$11:$O$13</c:f>
              <c:numCache>
                <c:formatCode>0_);[Red]\(0\)</c:formatCode>
                <c:ptCount val="3"/>
                <c:pt idx="0">
                  <c:v>28.450395470445038</c:v>
                </c:pt>
                <c:pt idx="1">
                  <c:v>30.858731268549427</c:v>
                </c:pt>
                <c:pt idx="2">
                  <c:v>26.968056439525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1A1-BB45-A0FF-1FD20A139DEA}"/>
            </c:ext>
          </c:extLst>
        </c:ser>
        <c:ser>
          <c:idx val="2"/>
          <c:order val="2"/>
          <c:tx>
            <c:strRef>
              <c:f>'表1，SCFA'!$P$10</c:f>
              <c:strCache>
                <c:ptCount val="1"/>
                <c:pt idx="0">
                  <c:v>nButyrate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SCFA'!$P$17:$P$19</c:f>
                <c:numCache>
                  <c:formatCode>General</c:formatCode>
                  <c:ptCount val="3"/>
                  <c:pt idx="0">
                    <c:v>0.48139252387474424</c:v>
                  </c:pt>
                  <c:pt idx="1">
                    <c:v>1.7661856579971786</c:v>
                  </c:pt>
                  <c:pt idx="2">
                    <c:v>1.44882405445133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P$11:$P$13</c:f>
              <c:numCache>
                <c:formatCode>0_);[Red]\(0\)</c:formatCode>
                <c:ptCount val="3"/>
                <c:pt idx="0">
                  <c:v>13.245499746850133</c:v>
                </c:pt>
                <c:pt idx="1">
                  <c:v>13.12376373167475</c:v>
                </c:pt>
                <c:pt idx="2">
                  <c:v>13.484993220848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1A1-BB45-A0FF-1FD20A139DEA}"/>
            </c:ext>
          </c:extLst>
        </c:ser>
        <c:ser>
          <c:idx val="3"/>
          <c:order val="3"/>
          <c:tx>
            <c:strRef>
              <c:f>'表1，SCFA'!$Q$10</c:f>
              <c:strCache>
                <c:ptCount val="1"/>
                <c:pt idx="0">
                  <c:v>isoButyrat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Q$11:$Q$13</c:f>
              <c:numCache>
                <c:formatCode>0_);[Red]\(0\)</c:formatCode>
                <c:ptCount val="3"/>
                <c:pt idx="0">
                  <c:v>0.73133873342076217</c:v>
                </c:pt>
                <c:pt idx="1">
                  <c:v>0.49220159215991111</c:v>
                </c:pt>
                <c:pt idx="2">
                  <c:v>0.615052144084700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1A1-BB45-A0FF-1FD20A139DEA}"/>
            </c:ext>
          </c:extLst>
        </c:ser>
        <c:ser>
          <c:idx val="4"/>
          <c:order val="4"/>
          <c:tx>
            <c:strRef>
              <c:f>'表1，SCFA'!$R$10</c:f>
              <c:strCache>
                <c:ptCount val="1"/>
                <c:pt idx="0">
                  <c:v>nValerate</c:v>
                </c:pt>
              </c:strCache>
            </c:strRef>
          </c:tx>
          <c:spPr>
            <a:solidFill>
              <a:srgbClr val="92D05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SCFA'!$R$17:$R$19</c:f>
                <c:numCache>
                  <c:formatCode>General</c:formatCode>
                  <c:ptCount val="3"/>
                  <c:pt idx="0">
                    <c:v>0.28087394826422779</c:v>
                  </c:pt>
                  <c:pt idx="1">
                    <c:v>0.6651436170520072</c:v>
                  </c:pt>
                  <c:pt idx="2">
                    <c:v>0.603018255754695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R$11:$R$13</c:f>
              <c:numCache>
                <c:formatCode>0_);[Red]\(0\)</c:formatCode>
                <c:ptCount val="3"/>
                <c:pt idx="0">
                  <c:v>1.3733891995800502</c:v>
                </c:pt>
                <c:pt idx="1">
                  <c:v>1.7053645952060907</c:v>
                </c:pt>
                <c:pt idx="2">
                  <c:v>1.72992042645904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A1-BB45-A0FF-1FD20A139DEA}"/>
            </c:ext>
          </c:extLst>
        </c:ser>
        <c:ser>
          <c:idx val="5"/>
          <c:order val="5"/>
          <c:tx>
            <c:strRef>
              <c:f>'表1，SCFA'!$S$10</c:f>
              <c:strCache>
                <c:ptCount val="1"/>
                <c:pt idx="0">
                  <c:v>isoValerat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S$11:$S$13</c:f>
              <c:numCache>
                <c:formatCode>0_);[Red]\(0\)</c:formatCode>
                <c:ptCount val="3"/>
                <c:pt idx="0">
                  <c:v>0.24942934421489463</c:v>
                </c:pt>
                <c:pt idx="1">
                  <c:v>0.13409880470542321</c:v>
                </c:pt>
                <c:pt idx="2">
                  <c:v>0.121162662849773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1A1-BB45-A0FF-1FD20A139DEA}"/>
            </c:ext>
          </c:extLst>
        </c:ser>
        <c:ser>
          <c:idx val="6"/>
          <c:order val="6"/>
          <c:tx>
            <c:strRef>
              <c:f>'表1，SCFA'!$T$10</c:f>
              <c:strCache>
                <c:ptCount val="1"/>
                <c:pt idx="0">
                  <c:v>Succinat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T$11:$T$13</c:f>
              <c:numCache>
                <c:formatCode>0_);[Red]\(0\)</c:formatCode>
                <c:ptCount val="3"/>
                <c:pt idx="0">
                  <c:v>0.24677866112681993</c:v>
                </c:pt>
                <c:pt idx="1">
                  <c:v>0.16784535099330819</c:v>
                </c:pt>
                <c:pt idx="2">
                  <c:v>0.153938855039827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1A1-BB45-A0FF-1FD20A139DEA}"/>
            </c:ext>
          </c:extLst>
        </c:ser>
        <c:ser>
          <c:idx val="7"/>
          <c:order val="7"/>
          <c:tx>
            <c:strRef>
              <c:f>'表1，SCFA'!$U$10</c:f>
              <c:strCache>
                <c:ptCount val="1"/>
                <c:pt idx="0">
                  <c:v>Lactate</c:v>
                </c:pt>
              </c:strCache>
            </c:strRef>
          </c:tx>
          <c:spPr>
            <a:solidFill>
              <a:srgbClr val="7030A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SCFA'!$U$17:$U$19</c:f>
                <c:numCache>
                  <c:formatCode>General</c:formatCode>
                  <c:ptCount val="3"/>
                  <c:pt idx="0">
                    <c:v>0.37248234607298814</c:v>
                  </c:pt>
                  <c:pt idx="1">
                    <c:v>3.7633423632563434</c:v>
                  </c:pt>
                  <c:pt idx="2">
                    <c:v>0.627170061569288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/>
                </a:solidFill>
                <a:round/>
              </a:ln>
              <a:effectLst/>
            </c:spPr>
          </c:errBars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U$11:$U$13</c:f>
              <c:numCache>
                <c:formatCode>0_);[Red]\(0\)</c:formatCode>
                <c:ptCount val="3"/>
                <c:pt idx="0">
                  <c:v>1.6866586914325323</c:v>
                </c:pt>
                <c:pt idx="1">
                  <c:v>5.8020167538275489</c:v>
                </c:pt>
                <c:pt idx="2">
                  <c:v>1.44343621561034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1A1-BB45-A0FF-1FD20A139DEA}"/>
            </c:ext>
          </c:extLst>
        </c:ser>
        <c:ser>
          <c:idx val="8"/>
          <c:order val="8"/>
          <c:tx>
            <c:strRef>
              <c:f>'表1，SCFA'!$V$10</c:f>
              <c:strCache>
                <c:ptCount val="1"/>
                <c:pt idx="0">
                  <c:v>Formate</c:v>
                </c:pt>
              </c:strCache>
            </c:strRef>
          </c:tx>
          <c:spPr>
            <a:solidFill>
              <a:srgbClr val="00206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表1，SCFA'!$M$11:$M$13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SCFA'!$V$11:$V$13</c:f>
              <c:numCache>
                <c:formatCode>0_);[Red]\(0\)</c:formatCode>
                <c:ptCount val="3"/>
                <c:pt idx="0">
                  <c:v>0</c:v>
                </c:pt>
                <c:pt idx="1">
                  <c:v>0.79782220554113237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1A1-BB45-A0FF-1FD20A139D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3436383"/>
        <c:axId val="373438063"/>
      </c:barChart>
      <c:catAx>
        <c:axId val="3734363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3438063"/>
        <c:crosses val="autoZero"/>
        <c:auto val="1"/>
        <c:lblAlgn val="ctr"/>
        <c:lblOffset val="100"/>
        <c:noMultiLvlLbl val="0"/>
      </c:catAx>
      <c:valAx>
        <c:axId val="37343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34363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表1，回腸'!$L$12</c:f>
              <c:strCache>
                <c:ptCount val="1"/>
                <c:pt idx="0">
                  <c:v>Acetate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回腸'!$L$18:$L$20</c:f>
                <c:numCache>
                  <c:formatCode>General</c:formatCode>
                  <c:ptCount val="3"/>
                  <c:pt idx="0">
                    <c:v>762.00733440553518</c:v>
                  </c:pt>
                  <c:pt idx="1">
                    <c:v>516.06050484250568</c:v>
                  </c:pt>
                  <c:pt idx="2">
                    <c:v>202.040156937432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L$13:$L$15</c:f>
              <c:numCache>
                <c:formatCode>0_ </c:formatCode>
                <c:ptCount val="3"/>
                <c:pt idx="0">
                  <c:v>2539.2269414636844</c:v>
                </c:pt>
                <c:pt idx="1">
                  <c:v>2294.3644795526798</c:v>
                </c:pt>
                <c:pt idx="2">
                  <c:v>2013.06476738965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F3-4A49-A557-B9DA574896FA}"/>
            </c:ext>
          </c:extLst>
        </c:ser>
        <c:ser>
          <c:idx val="1"/>
          <c:order val="1"/>
          <c:tx>
            <c:strRef>
              <c:f>'表1，回腸'!$M$12</c:f>
              <c:strCache>
                <c:ptCount val="1"/>
                <c:pt idx="0">
                  <c:v>Propionate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回腸'!$M$18:$M$20</c:f>
                <c:numCache>
                  <c:formatCode>General</c:formatCode>
                  <c:ptCount val="3"/>
                  <c:pt idx="0">
                    <c:v>558.33783419517033</c:v>
                  </c:pt>
                  <c:pt idx="1">
                    <c:v>426.7748652695891</c:v>
                  </c:pt>
                  <c:pt idx="2">
                    <c:v>222.304120134702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M$13:$M$15</c:f>
              <c:numCache>
                <c:formatCode>0_ </c:formatCode>
                <c:ptCount val="3"/>
                <c:pt idx="0">
                  <c:v>976.17920080834733</c:v>
                </c:pt>
                <c:pt idx="1">
                  <c:v>1266.1275177161426</c:v>
                </c:pt>
                <c:pt idx="2">
                  <c:v>856.526681092582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F3-4A49-A557-B9DA574896FA}"/>
            </c:ext>
          </c:extLst>
        </c:ser>
        <c:ser>
          <c:idx val="2"/>
          <c:order val="2"/>
          <c:tx>
            <c:strRef>
              <c:f>'表1，回腸'!$N$12</c:f>
              <c:strCache>
                <c:ptCount val="1"/>
                <c:pt idx="0">
                  <c:v>nButyrate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回腸'!$N$18:$N$20</c:f>
                <c:numCache>
                  <c:formatCode>General</c:formatCode>
                  <c:ptCount val="3"/>
                  <c:pt idx="0">
                    <c:v>346.35844999074413</c:v>
                  </c:pt>
                  <c:pt idx="1">
                    <c:v>826.6257990412804</c:v>
                  </c:pt>
                  <c:pt idx="2">
                    <c:v>155.321548885162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N$13:$N$15</c:f>
              <c:numCache>
                <c:formatCode>0_ </c:formatCode>
                <c:ptCount val="3"/>
                <c:pt idx="0">
                  <c:v>804.218977216138</c:v>
                </c:pt>
                <c:pt idx="1">
                  <c:v>1357.6994582161715</c:v>
                </c:pt>
                <c:pt idx="2">
                  <c:v>542.8691102553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1F3-4A49-A557-B9DA574896FA}"/>
            </c:ext>
          </c:extLst>
        </c:ser>
        <c:ser>
          <c:idx val="3"/>
          <c:order val="3"/>
          <c:tx>
            <c:strRef>
              <c:f>'表1，回腸'!$O$12</c:f>
              <c:strCache>
                <c:ptCount val="1"/>
                <c:pt idx="0">
                  <c:v>isoButyrat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回腸'!$O$18:$O$20</c:f>
                <c:numCache>
                  <c:formatCode>General</c:formatCode>
                  <c:ptCount val="3"/>
                  <c:pt idx="0">
                    <c:v>15.735770510596266</c:v>
                  </c:pt>
                  <c:pt idx="1">
                    <c:v>10.432093377007567</c:v>
                  </c:pt>
                  <c:pt idx="2">
                    <c:v>8.66362633804222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O$13:$O$15</c:f>
              <c:numCache>
                <c:formatCode>0_ </c:formatCode>
                <c:ptCount val="3"/>
                <c:pt idx="0">
                  <c:v>34.292247431026446</c:v>
                </c:pt>
                <c:pt idx="1">
                  <c:v>29.679730705186273</c:v>
                </c:pt>
                <c:pt idx="2">
                  <c:v>24.9897845902606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1F3-4A49-A557-B9DA574896FA}"/>
            </c:ext>
          </c:extLst>
        </c:ser>
        <c:ser>
          <c:idx val="4"/>
          <c:order val="4"/>
          <c:tx>
            <c:strRef>
              <c:f>'表1，回腸'!$P$12</c:f>
              <c:strCache>
                <c:ptCount val="1"/>
                <c:pt idx="0">
                  <c:v>nValerate</c:v>
                </c:pt>
              </c:strCache>
            </c:strRef>
          </c:tx>
          <c:spPr>
            <a:solidFill>
              <a:srgbClr val="92D05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1，回腸'!$P$18:$P$20</c:f>
                <c:numCache>
                  <c:formatCode>General</c:formatCode>
                  <c:ptCount val="3"/>
                  <c:pt idx="0">
                    <c:v>73.63969388392502</c:v>
                  </c:pt>
                  <c:pt idx="1">
                    <c:v>66.253953678720123</c:v>
                  </c:pt>
                  <c:pt idx="2">
                    <c:v>29.6508765967376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P$13:$P$15</c:f>
              <c:numCache>
                <c:formatCode>0_ </c:formatCode>
                <c:ptCount val="3"/>
                <c:pt idx="0">
                  <c:v>108.87398318773754</c:v>
                </c:pt>
                <c:pt idx="1">
                  <c:v>125.28592431480817</c:v>
                </c:pt>
                <c:pt idx="2">
                  <c:v>73.9825894340514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1F3-4A49-A557-B9DA574896FA}"/>
            </c:ext>
          </c:extLst>
        </c:ser>
        <c:ser>
          <c:idx val="5"/>
          <c:order val="5"/>
          <c:tx>
            <c:strRef>
              <c:f>'表1，回腸'!$Q$12</c:f>
              <c:strCache>
                <c:ptCount val="1"/>
                <c:pt idx="0">
                  <c:v>isoValerat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Q$13:$Q$15</c:f>
              <c:numCache>
                <c:formatCode>0_ </c:formatCode>
                <c:ptCount val="3"/>
                <c:pt idx="0">
                  <c:v>32.230118534915498</c:v>
                </c:pt>
                <c:pt idx="1">
                  <c:v>24.557975658190585</c:v>
                </c:pt>
                <c:pt idx="2">
                  <c:v>19.1222155563593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1F3-4A49-A557-B9DA574896FA}"/>
            </c:ext>
          </c:extLst>
        </c:ser>
        <c:ser>
          <c:idx val="6"/>
          <c:order val="6"/>
          <c:tx>
            <c:strRef>
              <c:f>'表1，回腸'!$R$12</c:f>
              <c:strCache>
                <c:ptCount val="1"/>
                <c:pt idx="0">
                  <c:v>Capronat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bg1"/>
              </a:solidFill>
            </a:ln>
            <a:effectLst/>
          </c:spPr>
          <c:invertIfNegative val="0"/>
          <c:cat>
            <c:strRef>
              <c:f>'表1，回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1，回腸'!$R$13:$R$15</c:f>
              <c:numCache>
                <c:formatCode>0_ </c:formatCode>
                <c:ptCount val="3"/>
                <c:pt idx="0">
                  <c:v>4.2760719193020673</c:v>
                </c:pt>
                <c:pt idx="1">
                  <c:v>12.22966385486427</c:v>
                </c:pt>
                <c:pt idx="2">
                  <c:v>7.22241051575303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1F3-4A49-A557-B9DA574896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3436383"/>
        <c:axId val="373438063"/>
      </c:barChart>
      <c:catAx>
        <c:axId val="3734363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3438063"/>
        <c:crosses val="autoZero"/>
        <c:auto val="1"/>
        <c:lblAlgn val="ctr"/>
        <c:lblOffset val="100"/>
        <c:noMultiLvlLbl val="0"/>
      </c:catAx>
      <c:valAx>
        <c:axId val="37343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 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34363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表2，盲腸'!$L$12</c:f>
              <c:strCache>
                <c:ptCount val="1"/>
                <c:pt idx="0">
                  <c:v>Acetate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2，盲腸'!$L$18:$L$20</c:f>
                <c:numCache>
                  <c:formatCode>General</c:formatCode>
                  <c:ptCount val="3"/>
                  <c:pt idx="0">
                    <c:v>951.48046268331484</c:v>
                  </c:pt>
                  <c:pt idx="1">
                    <c:v>484.91714754530398</c:v>
                  </c:pt>
                  <c:pt idx="2">
                    <c:v>695.882720455005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L$13:$L$15</c:f>
              <c:numCache>
                <c:formatCode>0_ </c:formatCode>
                <c:ptCount val="3"/>
                <c:pt idx="0">
                  <c:v>8081.1132654620742</c:v>
                </c:pt>
                <c:pt idx="1">
                  <c:v>5637.3017237009126</c:v>
                </c:pt>
                <c:pt idx="2">
                  <c:v>7205.3764856707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95E-D24B-B2EF-2ED2089A00D1}"/>
            </c:ext>
          </c:extLst>
        </c:ser>
        <c:ser>
          <c:idx val="1"/>
          <c:order val="1"/>
          <c:tx>
            <c:strRef>
              <c:f>'表2，盲腸'!$M$12</c:f>
              <c:strCache>
                <c:ptCount val="1"/>
                <c:pt idx="0">
                  <c:v>Propionate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2，盲腸'!$M$18:$M$20</c:f>
                <c:numCache>
                  <c:formatCode>General</c:formatCode>
                  <c:ptCount val="3"/>
                  <c:pt idx="0">
                    <c:v>657.84641146641002</c:v>
                  </c:pt>
                  <c:pt idx="1">
                    <c:v>433.82747779036004</c:v>
                  </c:pt>
                  <c:pt idx="2">
                    <c:v>538.833613033880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M$13:$M$15</c:f>
              <c:numCache>
                <c:formatCode>0_ </c:formatCode>
                <c:ptCount val="3"/>
                <c:pt idx="0">
                  <c:v>5075.3370578271779</c:v>
                </c:pt>
                <c:pt idx="1">
                  <c:v>3925.8842510986633</c:v>
                </c:pt>
                <c:pt idx="2">
                  <c:v>4339.4891414397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95E-D24B-B2EF-2ED2089A00D1}"/>
            </c:ext>
          </c:extLst>
        </c:ser>
        <c:ser>
          <c:idx val="2"/>
          <c:order val="2"/>
          <c:tx>
            <c:strRef>
              <c:f>'表2，盲腸'!$N$12</c:f>
              <c:strCache>
                <c:ptCount val="1"/>
                <c:pt idx="0">
                  <c:v>nButyrate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2，盲腸'!$N$18:$N$20</c:f>
                <c:numCache>
                  <c:formatCode>General</c:formatCode>
                  <c:ptCount val="3"/>
                  <c:pt idx="0">
                    <c:v>583.76273910102725</c:v>
                  </c:pt>
                  <c:pt idx="1">
                    <c:v>261.43347866131097</c:v>
                  </c:pt>
                  <c:pt idx="2">
                    <c:v>444.29581639991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N$13:$N$15</c:f>
              <c:numCache>
                <c:formatCode>0_ </c:formatCode>
                <c:ptCount val="3"/>
                <c:pt idx="0">
                  <c:v>3213.3934269644765</c:v>
                </c:pt>
                <c:pt idx="1">
                  <c:v>1843.4102538120371</c:v>
                </c:pt>
                <c:pt idx="2">
                  <c:v>2507.84805423193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95E-D24B-B2EF-2ED2089A00D1}"/>
            </c:ext>
          </c:extLst>
        </c:ser>
        <c:ser>
          <c:idx val="3"/>
          <c:order val="3"/>
          <c:tx>
            <c:strRef>
              <c:f>'表2，盲腸'!$O$12</c:f>
              <c:strCache>
                <c:ptCount val="1"/>
                <c:pt idx="0">
                  <c:v>isoButyrat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2，盲腸'!$O$18:$O$20</c:f>
                <c:numCache>
                  <c:formatCode>General</c:formatCode>
                  <c:ptCount val="3"/>
                  <c:pt idx="0">
                    <c:v>15.41356130628462</c:v>
                  </c:pt>
                  <c:pt idx="1">
                    <c:v>12.759612204945695</c:v>
                  </c:pt>
                  <c:pt idx="2">
                    <c:v>7.33422571736132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O$13:$O$15</c:f>
              <c:numCache>
                <c:formatCode>0_ </c:formatCode>
                <c:ptCount val="3"/>
                <c:pt idx="0">
                  <c:v>112.22288904728498</c:v>
                </c:pt>
                <c:pt idx="1">
                  <c:v>54.351205450189752</c:v>
                </c:pt>
                <c:pt idx="2">
                  <c:v>69.8715999556924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95E-D24B-B2EF-2ED2089A00D1}"/>
            </c:ext>
          </c:extLst>
        </c:ser>
        <c:ser>
          <c:idx val="4"/>
          <c:order val="4"/>
          <c:tx>
            <c:strRef>
              <c:f>'表2，盲腸'!$P$12</c:f>
              <c:strCache>
                <c:ptCount val="1"/>
                <c:pt idx="0">
                  <c:v>nValerate</c:v>
                </c:pt>
              </c:strCache>
            </c:strRef>
          </c:tx>
          <c:spPr>
            <a:solidFill>
              <a:srgbClr val="92D05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表2，盲腸'!$P$18:$P$20</c:f>
                <c:numCache>
                  <c:formatCode>General</c:formatCode>
                  <c:ptCount val="3"/>
                  <c:pt idx="0">
                    <c:v>44.820323057287602</c:v>
                  </c:pt>
                  <c:pt idx="1">
                    <c:v>73.344164430031398</c:v>
                  </c:pt>
                  <c:pt idx="2">
                    <c:v>92.0667558092557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P$13:$P$15</c:f>
              <c:numCache>
                <c:formatCode>0_ </c:formatCode>
                <c:ptCount val="3"/>
                <c:pt idx="0">
                  <c:v>387.87941557733717</c:v>
                </c:pt>
                <c:pt idx="1">
                  <c:v>289.32259341422605</c:v>
                </c:pt>
                <c:pt idx="2">
                  <c:v>347.19325374220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95E-D24B-B2EF-2ED2089A00D1}"/>
            </c:ext>
          </c:extLst>
        </c:ser>
        <c:ser>
          <c:idx val="5"/>
          <c:order val="5"/>
          <c:tx>
            <c:strRef>
              <c:f>'表2，盲腸'!$Q$12</c:f>
              <c:strCache>
                <c:ptCount val="1"/>
                <c:pt idx="0">
                  <c:v>isoValerat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Q$13:$Q$15</c:f>
              <c:numCache>
                <c:formatCode>0_ </c:formatCode>
                <c:ptCount val="3"/>
                <c:pt idx="0">
                  <c:v>79.033392203784345</c:v>
                </c:pt>
                <c:pt idx="1">
                  <c:v>41.358330164652763</c:v>
                </c:pt>
                <c:pt idx="2">
                  <c:v>50.4923325461219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95E-D24B-B2EF-2ED2089A00D1}"/>
            </c:ext>
          </c:extLst>
        </c:ser>
        <c:ser>
          <c:idx val="6"/>
          <c:order val="6"/>
          <c:tx>
            <c:strRef>
              <c:f>'表2，盲腸'!$R$12</c:f>
              <c:strCache>
                <c:ptCount val="1"/>
                <c:pt idx="0">
                  <c:v>Capronat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bg1"/>
              </a:solidFill>
            </a:ln>
            <a:effectLst/>
          </c:spPr>
          <c:invertIfNegative val="0"/>
          <c:cat>
            <c:strRef>
              <c:f>'表2，盲腸'!$K$13:$K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2，盲腸'!$R$13:$R$15</c:f>
              <c:numCache>
                <c:formatCode>0_ </c:formatCode>
                <c:ptCount val="3"/>
                <c:pt idx="0">
                  <c:v>9.2121751564311261</c:v>
                </c:pt>
                <c:pt idx="1">
                  <c:v>10.002525716149787</c:v>
                </c:pt>
                <c:pt idx="2">
                  <c:v>12.7196792561872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95E-D24B-B2EF-2ED2089A00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3436383"/>
        <c:axId val="373438063"/>
      </c:barChart>
      <c:catAx>
        <c:axId val="3734363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3438063"/>
        <c:crosses val="autoZero"/>
        <c:auto val="1"/>
        <c:lblAlgn val="ctr"/>
        <c:lblOffset val="100"/>
        <c:noMultiLvlLbl val="0"/>
      </c:catAx>
      <c:valAx>
        <c:axId val="3734380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 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734363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表3，Alpha_div'!$H$12</c:f>
              <c:strCache>
                <c:ptCount val="1"/>
                <c:pt idx="0">
                  <c:v>chao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0C7-4240-A71D-102A638EA99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F0C7-4240-A71D-102A638EA99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0C7-4240-A71D-102A638EA993}"/>
              </c:ext>
            </c:extLst>
          </c:dPt>
          <c:errBars>
            <c:errBarType val="plus"/>
            <c:errValType val="cust"/>
            <c:noEndCap val="0"/>
            <c:plus>
              <c:numRef>
                <c:f>'表3，Alpha_div'!$H$17:$H$19</c:f>
                <c:numCache>
                  <c:formatCode>General</c:formatCode>
                  <c:ptCount val="3"/>
                  <c:pt idx="0">
                    <c:v>29.36168319418589</c:v>
                  </c:pt>
                  <c:pt idx="1">
                    <c:v>25.090894581165092</c:v>
                  </c:pt>
                  <c:pt idx="2">
                    <c:v>30.0805999647779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3，Alpha_div'!$G$13:$G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3，Alpha_div'!$H$13:$H$15</c:f>
              <c:numCache>
                <c:formatCode>0_);[Red]\(0\)</c:formatCode>
                <c:ptCount val="3"/>
                <c:pt idx="0">
                  <c:v>349.76972789999996</c:v>
                </c:pt>
                <c:pt idx="1">
                  <c:v>362.49702379999997</c:v>
                </c:pt>
                <c:pt idx="2">
                  <c:v>323.447916674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C7-4240-A71D-102A638EA9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3072815"/>
        <c:axId val="1413063151"/>
      </c:barChart>
      <c:catAx>
        <c:axId val="141307281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13063151"/>
        <c:crosses val="autoZero"/>
        <c:auto val="1"/>
        <c:lblAlgn val="ctr"/>
        <c:lblOffset val="100"/>
        <c:noMultiLvlLbl val="0"/>
      </c:catAx>
      <c:valAx>
        <c:axId val="1413063151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13072815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表3，Alpha_div'!$J$12</c:f>
              <c:strCache>
                <c:ptCount val="1"/>
                <c:pt idx="0">
                  <c:v>shann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420-A545-B548-32FB724C74C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E420-A545-B548-32FB724C74C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420-A545-B548-32FB724C74CC}"/>
              </c:ext>
            </c:extLst>
          </c:dPt>
          <c:errBars>
            <c:errBarType val="plus"/>
            <c:errValType val="cust"/>
            <c:noEndCap val="0"/>
            <c:plus>
              <c:numRef>
                <c:f>'表3，Alpha_div'!$J$17:$J$19</c:f>
                <c:numCache>
                  <c:formatCode>General</c:formatCode>
                  <c:ptCount val="3"/>
                  <c:pt idx="0">
                    <c:v>0.1158354888064831</c:v>
                  </c:pt>
                  <c:pt idx="1">
                    <c:v>0.1805383782309731</c:v>
                  </c:pt>
                  <c:pt idx="2">
                    <c:v>0.180339504564008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表3，Alpha_div'!$I$13:$I$15</c:f>
              <c:strCache>
                <c:ptCount val="3"/>
                <c:pt idx="0">
                  <c:v>CC</c:v>
                </c:pt>
                <c:pt idx="1">
                  <c:v>PP</c:v>
                </c:pt>
                <c:pt idx="2">
                  <c:v>PC</c:v>
                </c:pt>
              </c:strCache>
            </c:strRef>
          </c:cat>
          <c:val>
            <c:numRef>
              <c:f>'表3，Alpha_div'!$J$13:$J$15</c:f>
              <c:numCache>
                <c:formatCode>0.0_);[Red]\(0.0\)</c:formatCode>
                <c:ptCount val="3"/>
                <c:pt idx="0">
                  <c:v>7.0155826287142862</c:v>
                </c:pt>
                <c:pt idx="1">
                  <c:v>6.9240331724999997</c:v>
                </c:pt>
                <c:pt idx="2">
                  <c:v>6.92235584687499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20-A545-B548-32FB724C74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8106847"/>
        <c:axId val="1348452063"/>
      </c:barChart>
      <c:catAx>
        <c:axId val="13481068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348452063"/>
        <c:crosses val="autoZero"/>
        <c:auto val="1"/>
        <c:lblAlgn val="ctr"/>
        <c:lblOffset val="100"/>
        <c:noMultiLvlLbl val="0"/>
      </c:catAx>
      <c:valAx>
        <c:axId val="1348452063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);[Red]\(0.0\)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348106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6B5E00-3AC0-E048-8C2D-35D6CDF026F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E99E97-DB0A-4046-949E-BAB181F15F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6380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E99E97-DB0A-4046-949E-BAB181F15F5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3592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3614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962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322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766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171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613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695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7204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412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034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4314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F3BF2-EB2F-EB40-9795-1010E0EB5EBB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7B8E4-644E-DE4F-82B4-7A410A37BD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7484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AADADEB-15DD-834E-AEC2-FC279418AC76}"/>
              </a:ext>
            </a:extLst>
          </p:cNvPr>
          <p:cNvSpPr txBox="1"/>
          <p:nvPr/>
        </p:nvSpPr>
        <p:spPr>
          <a:xfrm rot="16200000">
            <a:off x="-67030" y="7215686"/>
            <a:ext cx="4102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FA concentration in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e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in (µ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79C7B86-B36C-8F46-9773-6E2845081B6F}"/>
              </a:ext>
            </a:extLst>
          </p:cNvPr>
          <p:cNvSpPr txBox="1"/>
          <p:nvPr/>
        </p:nvSpPr>
        <p:spPr>
          <a:xfrm rot="16200000">
            <a:off x="-105502" y="12025490"/>
            <a:ext cx="4179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FA concentration in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in (µ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A5897FC-176E-A240-BBFA-0BC2ABB9B2F4}"/>
              </a:ext>
            </a:extLst>
          </p:cNvPr>
          <p:cNvSpPr txBox="1"/>
          <p:nvPr/>
        </p:nvSpPr>
        <p:spPr>
          <a:xfrm rot="16200000">
            <a:off x="-301870" y="2241714"/>
            <a:ext cx="45726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FA concentration in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est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mol/kg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87533EB-97F7-8042-A364-E668818E734A}"/>
              </a:ext>
            </a:extLst>
          </p:cNvPr>
          <p:cNvSpPr txBox="1"/>
          <p:nvPr/>
        </p:nvSpPr>
        <p:spPr>
          <a:xfrm>
            <a:off x="906795" y="14859325"/>
            <a:ext cx="111690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 Short-chain fatty acid </a:t>
            </a:r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lactate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in the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est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e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in and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in.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indicate the means, and the error bars indicate the standard errors. Red bar, acetate; Yellow bar, propionate; blue bar, n-butyrate; black bar,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utyrate; green bar, n-valerate, purple bar, lactate. </a:t>
            </a:r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, n=7; </a:t>
            </a:r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P and PC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s, n=8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B6E27C67-D462-5141-A443-123638C94D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5230859"/>
              </p:ext>
            </p:extLst>
          </p:nvPr>
        </p:nvGraphicFramePr>
        <p:xfrm>
          <a:off x="2169127" y="197631"/>
          <a:ext cx="7749573" cy="4515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09EC4C06-4F22-BA49-B6D4-99508382A2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9323435"/>
              </p:ext>
            </p:extLst>
          </p:nvPr>
        </p:nvGraphicFramePr>
        <p:xfrm>
          <a:off x="2273300" y="5246462"/>
          <a:ext cx="7645400" cy="4514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933FED4-C35A-1341-B88C-D5CAECA6D3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0561084"/>
              </p:ext>
            </p:extLst>
          </p:nvPr>
        </p:nvGraphicFramePr>
        <p:xfrm>
          <a:off x="2273300" y="10079265"/>
          <a:ext cx="7645400" cy="4514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683392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5FC5C02-527E-6B41-AF80-9ECD0357C502}"/>
              </a:ext>
            </a:extLst>
          </p:cNvPr>
          <p:cNvSpPr txBox="1"/>
          <p:nvPr/>
        </p:nvSpPr>
        <p:spPr>
          <a:xfrm>
            <a:off x="511454" y="10065658"/>
            <a:ext cx="1116909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Alpha indices of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robiota.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indicate the means, and the error bars indicate the standard errors. Open bar, control (</a:t>
            </a:r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;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7); Close bar, pigs supplemented with 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agulans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K70258 (</a:t>
            </a:r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P; n=8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Gray bar, pigs supplemented with 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agulans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K70258 at the weaning 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period but not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growing and fattening periods (</a:t>
            </a:r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;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8). Panel A, Chao1 index; Panel B, Shannon index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38E9F53-E3A2-E64A-B68F-142B19825D5A}"/>
              </a:ext>
            </a:extLst>
          </p:cNvPr>
          <p:cNvSpPr txBox="1"/>
          <p:nvPr/>
        </p:nvSpPr>
        <p:spPr>
          <a:xfrm>
            <a:off x="4445000" y="36412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D5BA2705-7D27-9E4C-9E3E-A1AD2C54C7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4055004"/>
              </p:ext>
            </p:extLst>
          </p:nvPr>
        </p:nvGraphicFramePr>
        <p:xfrm>
          <a:off x="3809999" y="344714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A934B3CA-DED6-EC47-922C-7787AC4188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6505667"/>
              </p:ext>
            </p:extLst>
          </p:nvPr>
        </p:nvGraphicFramePr>
        <p:xfrm>
          <a:off x="3810000" y="6756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3E5391A-F810-7A43-913D-7FF082736FD4}"/>
              </a:ext>
            </a:extLst>
          </p:cNvPr>
          <p:cNvSpPr txBox="1"/>
          <p:nvPr/>
        </p:nvSpPr>
        <p:spPr>
          <a:xfrm>
            <a:off x="4364578" y="686007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D2B6793-3C8E-8D4F-B64D-DF529D583837}"/>
              </a:ext>
            </a:extLst>
          </p:cNvPr>
          <p:cNvSpPr txBox="1"/>
          <p:nvPr/>
        </p:nvSpPr>
        <p:spPr>
          <a:xfrm rot="16200000">
            <a:off x="2917447" y="4533823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o 1 index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A4D35ED-8619-314A-A82A-464894EB2BD6}"/>
              </a:ext>
            </a:extLst>
          </p:cNvPr>
          <p:cNvSpPr txBox="1"/>
          <p:nvPr/>
        </p:nvSpPr>
        <p:spPr>
          <a:xfrm rot="16200000">
            <a:off x="2843709" y="7810220"/>
            <a:ext cx="1563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non index</a:t>
            </a:r>
          </a:p>
        </p:txBody>
      </p:sp>
    </p:spTree>
    <p:extLst>
      <p:ext uri="{BB962C8B-B14F-4D97-AF65-F5344CB8AC3E}">
        <p14:creationId xmlns:p14="http://schemas.microsoft.com/office/powerpoint/2010/main" val="1373123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47</TotalTime>
  <Words>209</Words>
  <Application>Microsoft Office PowerPoint</Application>
  <PresentationFormat>Custom</PresentationFormat>
  <Paragraphs>1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mitsu Tsukahara</dc:creator>
  <cp:lastModifiedBy>Gustavo Romero</cp:lastModifiedBy>
  <cp:revision>33</cp:revision>
  <dcterms:created xsi:type="dcterms:W3CDTF">2024-08-15T07:34:07Z</dcterms:created>
  <dcterms:modified xsi:type="dcterms:W3CDTF">2025-04-09T04:20:33Z</dcterms:modified>
</cp:coreProperties>
</file>